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66F0F-639C-4585-BE13-15E6BD465A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BFDDD7-494D-4351-987E-FDEAD19ADD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86E2A2-B2DE-4628-BB24-4C7BE987819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30C70-FD84-4099-BC02-CF5AFF2D69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915DAE-DDE8-416A-8268-23F826CF7A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FCEF42-1984-45B6-92D6-8F51ECA493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E7E85-23CB-4224-9442-6237503E87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D65699-9D58-4FE0-8FEA-D1223A4D87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6A9BE-36D5-4BBC-AF81-4001A294EA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B1AE2-9AF7-4FBC-8350-735B3D0415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2F207-A27C-49E9-8593-6E0D70F651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99BBC-F23A-4559-9401-7D7A71B33D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A7ADD9-FB73-4AF2-B502-677AEE181CD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package" Target="../embeddings/oleObject1.xlsx"/><Relationship Id="rId4" Type="http://schemas.openxmlformats.org/officeDocument/2006/relationships/image" Target="../media/image3.wmf"/><Relationship Id="rId5" Type="http://schemas.openxmlformats.org/officeDocument/2006/relationships/package" Target="../embeddings/oleObject2.xlsx"/><Relationship Id="rId6" Type="http://schemas.openxmlformats.org/officeDocument/2006/relationships/image" Target="../media/image4.wmf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9897" r="0" b="9897"/>
          <a:stretch/>
        </p:blipFill>
        <p:spPr>
          <a:xfrm>
            <a:off x="1011240" y="1436760"/>
            <a:ext cx="2432160" cy="19494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9897" r="0" b="12602"/>
          <a:stretch/>
        </p:blipFill>
        <p:spPr>
          <a:xfrm>
            <a:off x="3268800" y="1427040"/>
            <a:ext cx="2439720" cy="18907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499680" y="1319040"/>
            <a:ext cx="429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11200" y="3359160"/>
            <a:ext cx="414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3286080" y="4014720"/>
          <a:ext cx="2914560" cy="181764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3286080" y="4014720"/>
                    <a:ext cx="2914560" cy="1817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"/>
          <p:cNvSpPr/>
          <p:nvPr/>
        </p:nvSpPr>
        <p:spPr>
          <a:xfrm>
            <a:off x="3265560" y="3589200"/>
            <a:ext cx="414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130480" y="3192480"/>
            <a:ext cx="239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fluorescence intens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542040" y="5689440"/>
            <a:ext cx="2392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fluorescence intensit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904000" y="5291280"/>
            <a:ext cx="45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g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746680" y="5394240"/>
            <a:ext cx="165240" cy="44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973840" y="5173560"/>
            <a:ext cx="145800" cy="44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" bIns="-2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6050160" y="510372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ow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"/>
          <p:cNvGrpSpPr/>
          <p:nvPr/>
        </p:nvGrpSpPr>
        <p:grpSpPr>
          <a:xfrm>
            <a:off x="598320" y="3997440"/>
            <a:ext cx="2798640" cy="1989720"/>
            <a:chOff x="598320" y="3997440"/>
            <a:chExt cx="2798640" cy="1989720"/>
          </a:xfrm>
        </p:grpSpPr>
        <p:graphicFrame>
          <p:nvGraphicFramePr>
            <p:cNvPr id="55" name=""/>
            <p:cNvGraphicFramePr/>
            <p:nvPr/>
          </p:nvGraphicFramePr>
          <p:xfrm>
            <a:off x="847440" y="3997440"/>
            <a:ext cx="2549520" cy="164124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56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847440" y="3997440"/>
                      <a:ext cx="2549520" cy="1641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7" name=""/>
            <p:cNvSpPr/>
            <p:nvPr/>
          </p:nvSpPr>
          <p:spPr>
            <a:xfrm>
              <a:off x="1512360" y="5680080"/>
              <a:ext cx="1325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ell Area (</a:t>
              </a:r>
              <a:r>
                <a:rPr b="0" lang="en-US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</a:t>
              </a:r>
              <a:r>
                <a:rPr b="0" lang="en-US" sz="14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6200000">
              <a:off x="445680" y="5213520"/>
              <a:ext cx="396360" cy="91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4280" bIns="44280" anchor="t" vert="eaVer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"/>
          <p:cNvSpPr/>
          <p:nvPr/>
        </p:nvSpPr>
        <p:spPr>
          <a:xfrm rot="16200000">
            <a:off x="-217440" y="4619160"/>
            <a:ext cx="1936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 number of cell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5796000" y="5319720"/>
            <a:ext cx="165240" cy="44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5911920" y="5226120"/>
            <a:ext cx="164880" cy="44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rot="16200000">
            <a:off x="594360" y="2117880"/>
            <a:ext cx="68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unt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11-21T19:08:39Z</dcterms:created>
  <dc:creator>New Build</dc:creator>
  <dc:description/>
  <dc:language>en-US</dc:language>
  <cp:lastModifiedBy>New Build</cp:lastModifiedBy>
  <dcterms:modified xsi:type="dcterms:W3CDTF">2006-01-27T00:42:07Z</dcterms:modified>
  <cp:revision>5</cp:revision>
  <dc:subject/>
  <dc:title>Slide 1</dc:title>
</cp:coreProperties>
</file>